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034" autoAdjust="0"/>
    <p:restoredTop sz="94660"/>
  </p:normalViewPr>
  <p:slideViewPr>
    <p:cSldViewPr snapToGrid="0">
      <p:cViewPr varScale="1">
        <p:scale>
          <a:sx n="57" d="100"/>
          <a:sy n="57" d="100"/>
        </p:scale>
        <p:origin x="102" y="13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879D52-CF4B-4796-816A-A64630F64BE0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75D162-8D42-40BA-87D8-6E55128BC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89230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6466D-56F6-4642-9660-86E740DD436F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C1E6D-CAAD-4B95-BBE0-A7990C7DEF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5404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6466D-56F6-4642-9660-86E740DD436F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C1E6D-CAAD-4B95-BBE0-A7990C7DEF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24711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6466D-56F6-4642-9660-86E740DD436F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C1E6D-CAAD-4B95-BBE0-A7990C7DEF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24582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6466D-56F6-4642-9660-86E740DD436F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C1E6D-CAAD-4B95-BBE0-A7990C7DEF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2209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6466D-56F6-4642-9660-86E740DD436F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C1E6D-CAAD-4B95-BBE0-A7990C7DEF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3118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6466D-56F6-4642-9660-86E740DD436F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C1E6D-CAAD-4B95-BBE0-A7990C7DEF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52056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6466D-56F6-4642-9660-86E740DD436F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C1E6D-CAAD-4B95-BBE0-A7990C7DEF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32766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6466D-56F6-4642-9660-86E740DD436F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C1E6D-CAAD-4B95-BBE0-A7990C7DEF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5084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6466D-56F6-4642-9660-86E740DD436F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C1E6D-CAAD-4B95-BBE0-A7990C7DEF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6276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6466D-56F6-4642-9660-86E740DD436F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C1E6D-CAAD-4B95-BBE0-A7990C7DEF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22163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6466D-56F6-4642-9660-86E740DD436F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C1E6D-CAAD-4B95-BBE0-A7990C7DEF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1523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06466D-56F6-4642-9660-86E740DD436F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2C1E6D-CAAD-4B95-BBE0-A7990C7DEF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7415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-6" y="0"/>
          <a:ext cx="12191999" cy="685799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73774">
                  <a:extLst>
                    <a:ext uri="{9D8B030D-6E8A-4147-A177-3AD203B41FA5}">
                      <a16:colId xmlns:a16="http://schemas.microsoft.com/office/drawing/2014/main" val="1837845813"/>
                    </a:ext>
                  </a:extLst>
                </a:gridCol>
                <a:gridCol w="481264">
                  <a:extLst>
                    <a:ext uri="{9D8B030D-6E8A-4147-A177-3AD203B41FA5}">
                      <a16:colId xmlns:a16="http://schemas.microsoft.com/office/drawing/2014/main" val="330163347"/>
                    </a:ext>
                  </a:extLst>
                </a:gridCol>
                <a:gridCol w="994610">
                  <a:extLst>
                    <a:ext uri="{9D8B030D-6E8A-4147-A177-3AD203B41FA5}">
                      <a16:colId xmlns:a16="http://schemas.microsoft.com/office/drawing/2014/main" val="2246918880"/>
                    </a:ext>
                  </a:extLst>
                </a:gridCol>
                <a:gridCol w="834190">
                  <a:extLst>
                    <a:ext uri="{9D8B030D-6E8A-4147-A177-3AD203B41FA5}">
                      <a16:colId xmlns:a16="http://schemas.microsoft.com/office/drawing/2014/main" val="1032818362"/>
                    </a:ext>
                  </a:extLst>
                </a:gridCol>
                <a:gridCol w="513347">
                  <a:extLst>
                    <a:ext uri="{9D8B030D-6E8A-4147-A177-3AD203B41FA5}">
                      <a16:colId xmlns:a16="http://schemas.microsoft.com/office/drawing/2014/main" val="387130768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4201989523"/>
                    </a:ext>
                  </a:extLst>
                </a:gridCol>
                <a:gridCol w="657726">
                  <a:extLst>
                    <a:ext uri="{9D8B030D-6E8A-4147-A177-3AD203B41FA5}">
                      <a16:colId xmlns:a16="http://schemas.microsoft.com/office/drawing/2014/main" val="1506210741"/>
                    </a:ext>
                  </a:extLst>
                </a:gridCol>
                <a:gridCol w="699928">
                  <a:extLst>
                    <a:ext uri="{9D8B030D-6E8A-4147-A177-3AD203B41FA5}">
                      <a16:colId xmlns:a16="http://schemas.microsoft.com/office/drawing/2014/main" val="1349721508"/>
                    </a:ext>
                  </a:extLst>
                </a:gridCol>
                <a:gridCol w="455104">
                  <a:extLst>
                    <a:ext uri="{9D8B030D-6E8A-4147-A177-3AD203B41FA5}">
                      <a16:colId xmlns:a16="http://schemas.microsoft.com/office/drawing/2014/main" val="1822340970"/>
                    </a:ext>
                  </a:extLst>
                </a:gridCol>
                <a:gridCol w="804988">
                  <a:extLst>
                    <a:ext uri="{9D8B030D-6E8A-4147-A177-3AD203B41FA5}">
                      <a16:colId xmlns:a16="http://schemas.microsoft.com/office/drawing/2014/main" val="1483588572"/>
                    </a:ext>
                  </a:extLst>
                </a:gridCol>
                <a:gridCol w="690628">
                  <a:extLst>
                    <a:ext uri="{9D8B030D-6E8A-4147-A177-3AD203B41FA5}">
                      <a16:colId xmlns:a16="http://schemas.microsoft.com/office/drawing/2014/main" val="2056601952"/>
                    </a:ext>
                  </a:extLst>
                </a:gridCol>
                <a:gridCol w="581581">
                  <a:extLst>
                    <a:ext uri="{9D8B030D-6E8A-4147-A177-3AD203B41FA5}">
                      <a16:colId xmlns:a16="http://schemas.microsoft.com/office/drawing/2014/main" val="4272469271"/>
                    </a:ext>
                  </a:extLst>
                </a:gridCol>
                <a:gridCol w="581581">
                  <a:extLst>
                    <a:ext uri="{9D8B030D-6E8A-4147-A177-3AD203B41FA5}">
                      <a16:colId xmlns:a16="http://schemas.microsoft.com/office/drawing/2014/main" val="1791357255"/>
                    </a:ext>
                  </a:extLst>
                </a:gridCol>
                <a:gridCol w="581581">
                  <a:extLst>
                    <a:ext uri="{9D8B030D-6E8A-4147-A177-3AD203B41FA5}">
                      <a16:colId xmlns:a16="http://schemas.microsoft.com/office/drawing/2014/main" val="3930197055"/>
                    </a:ext>
                  </a:extLst>
                </a:gridCol>
                <a:gridCol w="581581">
                  <a:extLst>
                    <a:ext uri="{9D8B030D-6E8A-4147-A177-3AD203B41FA5}">
                      <a16:colId xmlns:a16="http://schemas.microsoft.com/office/drawing/2014/main" val="3748943751"/>
                    </a:ext>
                  </a:extLst>
                </a:gridCol>
                <a:gridCol w="581581">
                  <a:extLst>
                    <a:ext uri="{9D8B030D-6E8A-4147-A177-3AD203B41FA5}">
                      <a16:colId xmlns:a16="http://schemas.microsoft.com/office/drawing/2014/main" val="2447971627"/>
                    </a:ext>
                  </a:extLst>
                </a:gridCol>
                <a:gridCol w="581581">
                  <a:extLst>
                    <a:ext uri="{9D8B030D-6E8A-4147-A177-3AD203B41FA5}">
                      <a16:colId xmlns:a16="http://schemas.microsoft.com/office/drawing/2014/main" val="2482582456"/>
                    </a:ext>
                  </a:extLst>
                </a:gridCol>
                <a:gridCol w="645192">
                  <a:extLst>
                    <a:ext uri="{9D8B030D-6E8A-4147-A177-3AD203B41FA5}">
                      <a16:colId xmlns:a16="http://schemas.microsoft.com/office/drawing/2014/main" val="3377743854"/>
                    </a:ext>
                  </a:extLst>
                </a:gridCol>
                <a:gridCol w="642162">
                  <a:extLst>
                    <a:ext uri="{9D8B030D-6E8A-4147-A177-3AD203B41FA5}">
                      <a16:colId xmlns:a16="http://schemas.microsoft.com/office/drawing/2014/main" val="2750180293"/>
                    </a:ext>
                  </a:extLst>
                </a:gridCol>
              </a:tblGrid>
              <a:tr h="143539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Treatment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Animal 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</a:rPr>
                        <a:t>Day 1 </a:t>
                      </a:r>
                      <a:r>
                        <a:rPr lang="en-GB" sz="1200" b="1" u="none" strike="noStrike" dirty="0" err="1">
                          <a:effectLst/>
                        </a:rPr>
                        <a:t>Cortex:Pelvis</a:t>
                      </a:r>
                      <a:r>
                        <a:rPr lang="en-GB" sz="1200" b="1" u="none" strike="noStrike" dirty="0">
                          <a:effectLst/>
                        </a:rPr>
                        <a:t> AUC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Day 4 Cortex:Pelvis AUC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SCr (mg/dl)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BUN (mg/dl)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Day 1 ICG AUC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Day 4 ICG AUC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ALT (U/L)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Fractional Shortening Day 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Fractional Shortening Day 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Ejection Fraction Day 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Ejection Fraction Day 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Stroke Volume Day 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Stroke Volume Day 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Cardiac Output Day 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Cardiac Output Day 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Change in body weight (%) Day 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Change in Body Weight (%) Day 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extLst>
                  <a:ext uri="{0D108BD9-81ED-4DB2-BD59-A6C34878D82A}">
                    <a16:rowId xmlns:a16="http://schemas.microsoft.com/office/drawing/2014/main" val="695964803"/>
                  </a:ext>
                </a:extLst>
              </a:tr>
              <a:tr h="372140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Saline Only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.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6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7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4.8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91.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1.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3.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4.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6.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4.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4.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8.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7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9.5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3.8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extLst>
                  <a:ext uri="{0D108BD9-81ED-4DB2-BD59-A6C34878D82A}">
                    <a16:rowId xmlns:a16="http://schemas.microsoft.com/office/drawing/2014/main" val="2926679812"/>
                  </a:ext>
                </a:extLst>
              </a:tr>
              <a:tr h="3544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.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6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4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8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6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9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9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9.9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9.9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4.9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4.9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0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4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0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3.6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extLst>
                  <a:ext uri="{0D108BD9-81ED-4DB2-BD59-A6C34878D82A}">
                    <a16:rowId xmlns:a16="http://schemas.microsoft.com/office/drawing/2014/main" val="859838034"/>
                  </a:ext>
                </a:extLst>
              </a:tr>
              <a:tr h="3544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4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6.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9.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8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0.9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3.8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2.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7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8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4.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4.9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5.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39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1.5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extLst>
                  <a:ext uri="{0D108BD9-81ED-4DB2-BD59-A6C34878D82A}">
                    <a16:rowId xmlns:a16="http://schemas.microsoft.com/office/drawing/2014/main" val="4024243146"/>
                  </a:ext>
                </a:extLst>
              </a:tr>
              <a:tr h="3721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.9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1.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0.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2.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58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6.9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5.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5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2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8.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8.8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4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1.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0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1.1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extLst>
                  <a:ext uri="{0D108BD9-81ED-4DB2-BD59-A6C34878D82A}">
                    <a16:rowId xmlns:a16="http://schemas.microsoft.com/office/drawing/2014/main" val="1821486384"/>
                  </a:ext>
                </a:extLst>
              </a:tr>
              <a:tr h="372140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ADR + BMDMs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.9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.9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4.9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4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2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48.8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7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5.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6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51.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1.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5.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1.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8.7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17.0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extLst>
                  <a:ext uri="{0D108BD9-81ED-4DB2-BD59-A6C34878D82A}">
                    <a16:rowId xmlns:a16="http://schemas.microsoft.com/office/drawing/2014/main" val="1495772983"/>
                  </a:ext>
                </a:extLst>
              </a:tr>
              <a:tr h="3544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.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.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1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8.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52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13.9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4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7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9.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6.9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5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4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1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7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5.7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13.1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extLst>
                  <a:ext uri="{0D108BD9-81ED-4DB2-BD59-A6C34878D82A}">
                    <a16:rowId xmlns:a16="http://schemas.microsoft.com/office/drawing/2014/main" val="2636054090"/>
                  </a:ext>
                </a:extLst>
              </a:tr>
              <a:tr h="3544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5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0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7.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75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4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1.8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8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6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6.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2.8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5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10.8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22.09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extLst>
                  <a:ext uri="{0D108BD9-81ED-4DB2-BD59-A6C34878D82A}">
                    <a16:rowId xmlns:a16="http://schemas.microsoft.com/office/drawing/2014/main" val="2389222412"/>
                  </a:ext>
                </a:extLst>
              </a:tr>
              <a:tr h="3544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8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2.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5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1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70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1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8.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3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7.9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2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1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5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2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6.6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15.5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extLst>
                  <a:ext uri="{0D108BD9-81ED-4DB2-BD59-A6C34878D82A}">
                    <a16:rowId xmlns:a16="http://schemas.microsoft.com/office/drawing/2014/main" val="1707061765"/>
                  </a:ext>
                </a:extLst>
              </a:tr>
              <a:tr h="3544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9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8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4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6.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66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4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5.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8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3.9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2.8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7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5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5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11.8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24.89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extLst>
                  <a:ext uri="{0D108BD9-81ED-4DB2-BD59-A6C34878D82A}">
                    <a16:rowId xmlns:a16="http://schemas.microsoft.com/office/drawing/2014/main" val="3787117787"/>
                  </a:ext>
                </a:extLst>
              </a:tr>
              <a:tr h="3721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.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.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3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9.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9.8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36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8.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6.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55.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52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0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2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6.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6.9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4.3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19.2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extLst>
                  <a:ext uri="{0D108BD9-81ED-4DB2-BD59-A6C34878D82A}">
                    <a16:rowId xmlns:a16="http://schemas.microsoft.com/office/drawing/2014/main" val="2126536331"/>
                  </a:ext>
                </a:extLst>
              </a:tr>
              <a:tr h="372140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ADR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.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.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7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7.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64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00.9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1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3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3.8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8.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1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8.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4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7.0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14.5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extLst>
                  <a:ext uri="{0D108BD9-81ED-4DB2-BD59-A6C34878D82A}">
                    <a16:rowId xmlns:a16="http://schemas.microsoft.com/office/drawing/2014/main" val="1409397327"/>
                  </a:ext>
                </a:extLst>
              </a:tr>
              <a:tr h="3544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.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7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5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64.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96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3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6.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52.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53.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0.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8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3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.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10.3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16.5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extLst>
                  <a:ext uri="{0D108BD9-81ED-4DB2-BD59-A6C34878D82A}">
                    <a16:rowId xmlns:a16="http://schemas.microsoft.com/office/drawing/2014/main" val="3698930257"/>
                  </a:ext>
                </a:extLst>
              </a:tr>
              <a:tr h="3544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.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5.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6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5.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16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2.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1.8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4.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5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7.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0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7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5.9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13.18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21.3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extLst>
                  <a:ext uri="{0D108BD9-81ED-4DB2-BD59-A6C34878D82A}">
                    <a16:rowId xmlns:a16="http://schemas.microsoft.com/office/drawing/2014/main" val="849141024"/>
                  </a:ext>
                </a:extLst>
              </a:tr>
              <a:tr h="35441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</a:rPr>
                        <a:t>5.6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8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3.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5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62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389.2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2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2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5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7.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7.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4.7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9.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5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7.5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16.2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extLst>
                  <a:ext uri="{0D108BD9-81ED-4DB2-BD59-A6C34878D82A}">
                    <a16:rowId xmlns:a16="http://schemas.microsoft.com/office/drawing/2014/main" val="4152766677"/>
                  </a:ext>
                </a:extLst>
              </a:tr>
              <a:tr h="3721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5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0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.4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4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8.1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51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30.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4.8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2.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9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26.8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4.8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2.8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15.6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4.3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>
                          <a:effectLst/>
                        </a:rPr>
                        <a:t>-10.00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</a:rPr>
                        <a:t>-21.67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007" marR="8007" marT="8007" marB="0" anchor="ctr"/>
                </a:tc>
                <a:extLst>
                  <a:ext uri="{0D108BD9-81ED-4DB2-BD59-A6C34878D82A}">
                    <a16:rowId xmlns:a16="http://schemas.microsoft.com/office/drawing/2014/main" val="270604228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474011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379</Words>
  <Application>Microsoft Office PowerPoint</Application>
  <PresentationFormat>Widescreen</PresentationFormat>
  <Paragraphs>29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The University of Liverpo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rkey, Jack [jsharkey]</dc:creator>
  <cp:lastModifiedBy>Sharkey, Jack [jsharkey]</cp:lastModifiedBy>
  <cp:revision>12</cp:revision>
  <dcterms:created xsi:type="dcterms:W3CDTF">2019-02-18T14:02:08Z</dcterms:created>
  <dcterms:modified xsi:type="dcterms:W3CDTF">2019-02-18T14:11:29Z</dcterms:modified>
</cp:coreProperties>
</file>